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56" r:id="rId3"/>
    <p:sldId id="257" r:id="rId4"/>
    <p:sldId id="258" r:id="rId5"/>
    <p:sldId id="259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617" autoAdjust="0"/>
    <p:restoredTop sz="94660"/>
  </p:normalViewPr>
  <p:slideViewPr>
    <p:cSldViewPr snapToGrid="0" showGuides="1">
      <p:cViewPr varScale="1">
        <p:scale>
          <a:sx n="70" d="100"/>
          <a:sy n="70" d="100"/>
        </p:scale>
        <p:origin x="576" y="5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F8C4C2-0A6C-4308-B048-6452B71965A0}" type="datetimeFigureOut">
              <a:rPr lang="en-US" smtClean="0"/>
              <a:t>5/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57EFC-F091-4A31-BA61-74EBDE3559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9212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F8C4C2-0A6C-4308-B048-6452B71965A0}" type="datetimeFigureOut">
              <a:rPr lang="en-US" smtClean="0"/>
              <a:t>5/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57EFC-F091-4A31-BA61-74EBDE3559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47971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F8C4C2-0A6C-4308-B048-6452B71965A0}" type="datetimeFigureOut">
              <a:rPr lang="en-US" smtClean="0"/>
              <a:t>5/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57EFC-F091-4A31-BA61-74EBDE3559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88466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F8C4C2-0A6C-4308-B048-6452B71965A0}" type="datetimeFigureOut">
              <a:rPr lang="en-US" smtClean="0"/>
              <a:t>5/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57EFC-F091-4A31-BA61-74EBDE3559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2954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F8C4C2-0A6C-4308-B048-6452B71965A0}" type="datetimeFigureOut">
              <a:rPr lang="en-US" smtClean="0"/>
              <a:t>5/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57EFC-F091-4A31-BA61-74EBDE3559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22217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F8C4C2-0A6C-4308-B048-6452B71965A0}" type="datetimeFigureOut">
              <a:rPr lang="en-US" smtClean="0"/>
              <a:t>5/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57EFC-F091-4A31-BA61-74EBDE3559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9268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F8C4C2-0A6C-4308-B048-6452B71965A0}" type="datetimeFigureOut">
              <a:rPr lang="en-US" smtClean="0"/>
              <a:t>5/6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57EFC-F091-4A31-BA61-74EBDE3559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38261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F8C4C2-0A6C-4308-B048-6452B71965A0}" type="datetimeFigureOut">
              <a:rPr lang="en-US" smtClean="0"/>
              <a:t>5/6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57EFC-F091-4A31-BA61-74EBDE3559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44238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F8C4C2-0A6C-4308-B048-6452B71965A0}" type="datetimeFigureOut">
              <a:rPr lang="en-US" smtClean="0"/>
              <a:t>5/6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57EFC-F091-4A31-BA61-74EBDE3559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19244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F8C4C2-0A6C-4308-B048-6452B71965A0}" type="datetimeFigureOut">
              <a:rPr lang="en-US" smtClean="0"/>
              <a:t>5/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57EFC-F091-4A31-BA61-74EBDE3559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68394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F8C4C2-0A6C-4308-B048-6452B71965A0}" type="datetimeFigureOut">
              <a:rPr lang="en-US" smtClean="0"/>
              <a:t>5/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57EFC-F091-4A31-BA61-74EBDE3559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52873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F8C4C2-0A6C-4308-B048-6452B71965A0}" type="datetimeFigureOut">
              <a:rPr lang="en-US" smtClean="0"/>
              <a:t>5/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657EFC-F091-4A31-BA61-74EBDE3559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80398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2994167"/>
            <a:ext cx="9144000" cy="869666"/>
          </a:xfrm>
        </p:spPr>
        <p:txBody>
          <a:bodyPr>
            <a:normAutofit fontScale="90000"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s of models results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83233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55882397"/>
              </p:ext>
            </p:extLst>
          </p:nvPr>
        </p:nvGraphicFramePr>
        <p:xfrm>
          <a:off x="-1" y="1298118"/>
          <a:ext cx="12192000" cy="4261764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3141627">
                  <a:extLst>
                    <a:ext uri="{9D8B030D-6E8A-4147-A177-3AD203B41FA5}">
                      <a16:colId xmlns:a16="http://schemas.microsoft.com/office/drawing/2014/main" val="3604958317"/>
                    </a:ext>
                  </a:extLst>
                </a:gridCol>
                <a:gridCol w="922373">
                  <a:extLst>
                    <a:ext uri="{9D8B030D-6E8A-4147-A177-3AD203B41FA5}">
                      <a16:colId xmlns:a16="http://schemas.microsoft.com/office/drawing/2014/main" val="2757122794"/>
                    </a:ext>
                  </a:extLst>
                </a:gridCol>
                <a:gridCol w="2032000">
                  <a:extLst>
                    <a:ext uri="{9D8B030D-6E8A-4147-A177-3AD203B41FA5}">
                      <a16:colId xmlns:a16="http://schemas.microsoft.com/office/drawing/2014/main" val="1387409480"/>
                    </a:ext>
                  </a:extLst>
                </a:gridCol>
                <a:gridCol w="2032000">
                  <a:extLst>
                    <a:ext uri="{9D8B030D-6E8A-4147-A177-3AD203B41FA5}">
                      <a16:colId xmlns:a16="http://schemas.microsoft.com/office/drawing/2014/main" val="2106423391"/>
                    </a:ext>
                  </a:extLst>
                </a:gridCol>
                <a:gridCol w="2032000">
                  <a:extLst>
                    <a:ext uri="{9D8B030D-6E8A-4147-A177-3AD203B41FA5}">
                      <a16:colId xmlns:a16="http://schemas.microsoft.com/office/drawing/2014/main" val="1993776501"/>
                    </a:ext>
                  </a:extLst>
                </a:gridCol>
                <a:gridCol w="2032000">
                  <a:extLst>
                    <a:ext uri="{9D8B030D-6E8A-4147-A177-3AD203B41FA5}">
                      <a16:colId xmlns:a16="http://schemas.microsoft.com/office/drawing/2014/main" val="4108294907"/>
                    </a:ext>
                  </a:extLst>
                </a:gridCol>
              </a:tblGrid>
              <a:tr h="4766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xed </a:t>
                      </a:r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ffects GLMER 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stimate Std.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ror 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 value 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</a:t>
                      </a:r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&gt;|z|)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gnificance level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191076331"/>
                  </a:ext>
                </a:extLst>
              </a:tr>
              <a:tr h="47102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Intercept)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5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74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88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6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619715337"/>
                  </a:ext>
                </a:extLst>
              </a:tr>
              <a:tr h="47102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PupilDiameter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-296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74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67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3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078234699"/>
                  </a:ext>
                </a:extLst>
              </a:tr>
              <a:tr h="47102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obotBehavior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4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37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87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864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324329020"/>
                  </a:ext>
                </a:extLst>
              </a:tr>
              <a:tr h="47102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as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26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6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2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457076274"/>
                  </a:ext>
                </a:extLst>
              </a:tr>
              <a:tr h="4766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PupilDiameter:RobotBehavior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4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29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37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755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40804075"/>
                  </a:ext>
                </a:extLst>
              </a:tr>
              <a:tr h="4766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 err="1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PupilDiameter:Bias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4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1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076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49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2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954179109"/>
                  </a:ext>
                </a:extLst>
              </a:tr>
              <a:tr h="47102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obotBehavior:Bias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4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54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4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67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791155751"/>
                  </a:ext>
                </a:extLst>
              </a:tr>
              <a:tr h="4766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PupilDiameter:RobotBehavior:Bias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85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239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46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5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335270348"/>
                  </a:ext>
                </a:extLst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2431576" y="259307"/>
            <a:ext cx="73288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sults of Generalized Linear Mixed Effect Model on the total sample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-14872" y="6229361"/>
            <a:ext cx="601735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fr-FR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ignifiance </a:t>
            </a:r>
            <a:r>
              <a:rPr lang="fr-FR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des:  0 ‘***’ 0.001 ‘**’ 0.01 ‘*’ 0.05 ‘.’ 0.1 ‘ ’ 1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191140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00154304"/>
              </p:ext>
            </p:extLst>
          </p:nvPr>
        </p:nvGraphicFramePr>
        <p:xfrm>
          <a:off x="-2" y="1866334"/>
          <a:ext cx="12192004" cy="2733933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2768602">
                  <a:extLst>
                    <a:ext uri="{9D8B030D-6E8A-4147-A177-3AD203B41FA5}">
                      <a16:colId xmlns:a16="http://schemas.microsoft.com/office/drawing/2014/main" val="3159651016"/>
                    </a:ext>
                  </a:extLst>
                </a:gridCol>
                <a:gridCol w="1295398">
                  <a:extLst>
                    <a:ext uri="{9D8B030D-6E8A-4147-A177-3AD203B41FA5}">
                      <a16:colId xmlns:a16="http://schemas.microsoft.com/office/drawing/2014/main" val="2274126094"/>
                    </a:ext>
                  </a:extLst>
                </a:gridCol>
                <a:gridCol w="2032001">
                  <a:extLst>
                    <a:ext uri="{9D8B030D-6E8A-4147-A177-3AD203B41FA5}">
                      <a16:colId xmlns:a16="http://schemas.microsoft.com/office/drawing/2014/main" val="2871818829"/>
                    </a:ext>
                  </a:extLst>
                </a:gridCol>
                <a:gridCol w="2032001">
                  <a:extLst>
                    <a:ext uri="{9D8B030D-6E8A-4147-A177-3AD203B41FA5}">
                      <a16:colId xmlns:a16="http://schemas.microsoft.com/office/drawing/2014/main" val="1764270778"/>
                    </a:ext>
                  </a:extLst>
                </a:gridCol>
                <a:gridCol w="2032001">
                  <a:extLst>
                    <a:ext uri="{9D8B030D-6E8A-4147-A177-3AD203B41FA5}">
                      <a16:colId xmlns:a16="http://schemas.microsoft.com/office/drawing/2014/main" val="546197237"/>
                    </a:ext>
                  </a:extLst>
                </a:gridCol>
                <a:gridCol w="2032001">
                  <a:extLst>
                    <a:ext uri="{9D8B030D-6E8A-4147-A177-3AD203B41FA5}">
                      <a16:colId xmlns:a16="http://schemas.microsoft.com/office/drawing/2014/main" val="350622921"/>
                    </a:ext>
                  </a:extLst>
                </a:gridCol>
              </a:tblGrid>
              <a:tr h="80246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xed </a:t>
                      </a:r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ffects GLMER </a:t>
                      </a:r>
                      <a:r>
                        <a:rPr lang="en-US" sz="14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chanistic </a:t>
                      </a:r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ased group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stimate Std.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ror 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 value 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(&gt;|z|)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gnificance level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715606198"/>
                  </a:ext>
                </a:extLst>
              </a:tr>
              <a:tr h="58071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Intercept)                    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4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3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6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4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89923221"/>
                  </a:ext>
                </a:extLst>
              </a:tr>
              <a:tr h="43666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PupilDiameter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0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7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7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3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822122704"/>
                  </a:ext>
                </a:extLst>
              </a:tr>
              <a:tr h="3333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obotBehavior             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-</a:t>
                      </a:r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87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86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520082534"/>
                  </a:ext>
                </a:extLst>
              </a:tr>
              <a:tr h="58071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PupilDiameter:RobotBehavior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284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36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757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</a:t>
                      </a:r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34890010"/>
                  </a:ext>
                </a:extLst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2431576" y="259307"/>
            <a:ext cx="732884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sults of Generalized Linear Mixed Effect Model on the Mechanistic Biased sample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-14872" y="6229361"/>
            <a:ext cx="601735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fr-FR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ignifiance </a:t>
            </a:r>
            <a:r>
              <a:rPr lang="fr-FR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des:  0 ‘***’ 0.001 ‘**’ 0.01 ‘*’ 0.05 ‘.’ 0.1 ‘ ’ 1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276642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52114836"/>
              </p:ext>
            </p:extLst>
          </p:nvPr>
        </p:nvGraphicFramePr>
        <p:xfrm>
          <a:off x="-1" y="2248627"/>
          <a:ext cx="12192000" cy="2360746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2641601">
                  <a:extLst>
                    <a:ext uri="{9D8B030D-6E8A-4147-A177-3AD203B41FA5}">
                      <a16:colId xmlns:a16="http://schemas.microsoft.com/office/drawing/2014/main" val="3604958317"/>
                    </a:ext>
                  </a:extLst>
                </a:gridCol>
                <a:gridCol w="1422399">
                  <a:extLst>
                    <a:ext uri="{9D8B030D-6E8A-4147-A177-3AD203B41FA5}">
                      <a16:colId xmlns:a16="http://schemas.microsoft.com/office/drawing/2014/main" val="2757122794"/>
                    </a:ext>
                  </a:extLst>
                </a:gridCol>
                <a:gridCol w="2032000">
                  <a:extLst>
                    <a:ext uri="{9D8B030D-6E8A-4147-A177-3AD203B41FA5}">
                      <a16:colId xmlns:a16="http://schemas.microsoft.com/office/drawing/2014/main" val="1387409480"/>
                    </a:ext>
                  </a:extLst>
                </a:gridCol>
                <a:gridCol w="2032000">
                  <a:extLst>
                    <a:ext uri="{9D8B030D-6E8A-4147-A177-3AD203B41FA5}">
                      <a16:colId xmlns:a16="http://schemas.microsoft.com/office/drawing/2014/main" val="2106423391"/>
                    </a:ext>
                  </a:extLst>
                </a:gridCol>
                <a:gridCol w="2032000">
                  <a:extLst>
                    <a:ext uri="{9D8B030D-6E8A-4147-A177-3AD203B41FA5}">
                      <a16:colId xmlns:a16="http://schemas.microsoft.com/office/drawing/2014/main" val="1993776501"/>
                    </a:ext>
                  </a:extLst>
                </a:gridCol>
                <a:gridCol w="2032000">
                  <a:extLst>
                    <a:ext uri="{9D8B030D-6E8A-4147-A177-3AD203B41FA5}">
                      <a16:colId xmlns:a16="http://schemas.microsoft.com/office/drawing/2014/main" val="4108294907"/>
                    </a:ext>
                  </a:extLst>
                </a:gridCol>
              </a:tblGrid>
              <a:tr h="4766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xed </a:t>
                      </a:r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ffects GLMER Mentalistic biased group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stimat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d. Error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 valu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(&gt;|z|)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gnificance level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191076331"/>
                  </a:ext>
                </a:extLst>
              </a:tr>
              <a:tr h="47102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Intercept)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2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2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9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9 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619715337"/>
                  </a:ext>
                </a:extLst>
              </a:tr>
              <a:tr h="47102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PupilDiameter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7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6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97 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9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078234699"/>
                  </a:ext>
                </a:extLst>
              </a:tr>
              <a:tr h="47102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obotBehavior             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49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7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18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324329020"/>
                  </a:ext>
                </a:extLst>
              </a:tr>
              <a:tr h="47102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PupilDiameter:RobotBehavior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45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7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73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457076274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2431576" y="259307"/>
            <a:ext cx="732884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sults of Generalized Linear Mixed Effect Model on the Mentalistic Biased sample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-14872" y="6229361"/>
            <a:ext cx="601735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fr-FR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ignifiance </a:t>
            </a:r>
            <a:r>
              <a:rPr lang="fr-FR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des:  0 ‘***’ 0.001 ‘**’ 0.01 ‘*’ 0.05 ‘.’ 0.1 ‘ ’ 1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459670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47496857"/>
              </p:ext>
            </p:extLst>
          </p:nvPr>
        </p:nvGraphicFramePr>
        <p:xfrm>
          <a:off x="322999" y="2719647"/>
          <a:ext cx="11546003" cy="1418706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1649429">
                  <a:extLst>
                    <a:ext uri="{9D8B030D-6E8A-4147-A177-3AD203B41FA5}">
                      <a16:colId xmlns:a16="http://schemas.microsoft.com/office/drawing/2014/main" val="3604958317"/>
                    </a:ext>
                  </a:extLst>
                </a:gridCol>
                <a:gridCol w="1649429">
                  <a:extLst>
                    <a:ext uri="{9D8B030D-6E8A-4147-A177-3AD203B41FA5}">
                      <a16:colId xmlns:a16="http://schemas.microsoft.com/office/drawing/2014/main" val="359338433"/>
                    </a:ext>
                  </a:extLst>
                </a:gridCol>
                <a:gridCol w="1649429">
                  <a:extLst>
                    <a:ext uri="{9D8B030D-6E8A-4147-A177-3AD203B41FA5}">
                      <a16:colId xmlns:a16="http://schemas.microsoft.com/office/drawing/2014/main" val="2757122794"/>
                    </a:ext>
                  </a:extLst>
                </a:gridCol>
                <a:gridCol w="1649429">
                  <a:extLst>
                    <a:ext uri="{9D8B030D-6E8A-4147-A177-3AD203B41FA5}">
                      <a16:colId xmlns:a16="http://schemas.microsoft.com/office/drawing/2014/main" val="1387409480"/>
                    </a:ext>
                  </a:extLst>
                </a:gridCol>
                <a:gridCol w="1649429">
                  <a:extLst>
                    <a:ext uri="{9D8B030D-6E8A-4147-A177-3AD203B41FA5}">
                      <a16:colId xmlns:a16="http://schemas.microsoft.com/office/drawing/2014/main" val="2106423391"/>
                    </a:ext>
                  </a:extLst>
                </a:gridCol>
                <a:gridCol w="1649429">
                  <a:extLst>
                    <a:ext uri="{9D8B030D-6E8A-4147-A177-3AD203B41FA5}">
                      <a16:colId xmlns:a16="http://schemas.microsoft.com/office/drawing/2014/main" val="1993776501"/>
                    </a:ext>
                  </a:extLst>
                </a:gridCol>
                <a:gridCol w="1649429">
                  <a:extLst>
                    <a:ext uri="{9D8B030D-6E8A-4147-A177-3AD203B41FA5}">
                      <a16:colId xmlns:a16="http://schemas.microsoft.com/office/drawing/2014/main" val="4108294907"/>
                    </a:ext>
                  </a:extLst>
                </a:gridCol>
              </a:tblGrid>
              <a:tr h="4766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xed </a:t>
                      </a:r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ffects LMER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stimat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d. Error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f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 valu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(&gt;|t|)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gnificance level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191076331"/>
                  </a:ext>
                </a:extLst>
              </a:tr>
              <a:tr h="47102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Intercept)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96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6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458.94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80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*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619715337"/>
                  </a:ext>
                </a:extLst>
              </a:tr>
              <a:tr h="47102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_ISS</a:t>
                      </a:r>
                      <a:r>
                        <a:rPr lang="en-US" sz="14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46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1.999.69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9.73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*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078234699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2431576" y="259307"/>
            <a:ext cx="73288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sults of  Linear Mixed Effect Model on the total sample sample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322999" y="5212834"/>
            <a:ext cx="441659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/>
            <a:r>
              <a:rPr lang="en-US" b="1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z_ISS</a:t>
            </a:r>
            <a:r>
              <a:rPr lang="en-US" b="1" baseline="300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 </a:t>
            </a:r>
            <a:r>
              <a:rPr lang="en-US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: z corrected quadratic InStance Score </a:t>
            </a:r>
            <a:endParaRPr lang="en-US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-14872" y="6229361"/>
            <a:ext cx="601735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fr-FR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ignifiance </a:t>
            </a:r>
            <a:r>
              <a:rPr lang="fr-FR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des:  0 ‘***’ 0.001 ‘**’ 0.01 ‘*’ 0.05 ‘.’ 0.1 ‘ ’ 1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433315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7</TotalTime>
  <Words>317</Words>
  <Application>Microsoft Office PowerPoint</Application>
  <PresentationFormat>Widescreen</PresentationFormat>
  <Paragraphs>136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Tables of models results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rena Marchesi</dc:creator>
  <cp:lastModifiedBy>Serena Marchesi</cp:lastModifiedBy>
  <cp:revision>52</cp:revision>
  <dcterms:created xsi:type="dcterms:W3CDTF">2021-05-06T07:23:34Z</dcterms:created>
  <dcterms:modified xsi:type="dcterms:W3CDTF">2021-05-06T08:16:39Z</dcterms:modified>
</cp:coreProperties>
</file>